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5119FB-92B1-4299-A1BF-E64C4DF4B2FC}" v="6" dt="2025-11-02T22:02:37.290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undo custSel addSld modSld modMainMaster">
      <pc:chgData name="Sobel, Raymond" userId="682ea7fd-2081-4ef7-9ccf-cc036b672067" providerId="ADAL" clId="{327064EF-D6E0-4CA7-937D-5219C7D36AD4}" dt="2025-11-02T22:05:18.115" v="338" actId="1036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05:18.115" v="338" actId="1036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05:18.115" v="338" actId="1036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1:58:20.976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del mod">
          <ac:chgData name="Sobel, Raymond" userId="682ea7fd-2081-4ef7-9ccf-cc036b672067" providerId="ADAL" clId="{327064EF-D6E0-4CA7-937D-5219C7D36AD4}" dt="2025-11-02T22:02:35.350" v="189" actId="22"/>
          <ac:picMkLst>
            <pc:docMk/>
            <pc:sldMk cId="3744564216" sldId="256"/>
            <ac:picMk id="5" creationId="{1C21A08C-4675-F840-2E10-62A3AB665585}"/>
          </ac:picMkLst>
        </pc:picChg>
        <pc:picChg chg="add mod">
          <ac:chgData name="Sobel, Raymond" userId="682ea7fd-2081-4ef7-9ccf-cc036b672067" providerId="ADAL" clId="{327064EF-D6E0-4CA7-937D-5219C7D36AD4}" dt="2025-11-02T22:03:00.594" v="198" actId="1076"/>
          <ac:picMkLst>
            <pc:docMk/>
            <pc:sldMk cId="3744564216" sldId="256"/>
            <ac:picMk id="7" creationId="{0AF45F89-BEF0-826D-4DC4-1CCB0C890112}"/>
          </ac:picMkLst>
        </pc:picChg>
      </pc:sldChg>
      <pc:sldMasterChg chg="modSp modSldLayout">
        <pc:chgData name="Sobel, Raymond" userId="682ea7fd-2081-4ef7-9ccf-cc036b672067" providerId="ADAL" clId="{327064EF-D6E0-4CA7-937D-5219C7D36AD4}" dt="2025-11-02T22:02:37.290" v="192"/>
        <pc:sldMasterMkLst>
          <pc:docMk/>
          <pc:sldMasterMk cId="1136608070" sldId="2147483648"/>
        </pc:sldMasterMkLst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2" creationId="{F8EABF90-C8C6-258C-D545-2FDDE03F65EF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3" creationId="{2D87894B-552E-2C03-AAEA-665D50462D31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4" creationId="{D940C522-B832-62D4-48D3-4D791369137D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5" creationId="{1351F338-9539-B24F-421B-DFBC140BEABB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6" creationId="{2941CA7C-86C7-4830-0048-93FD2296F519}"/>
          </ac:spMkLst>
        </pc:sp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991882961" sldId="214748364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2" creationId="{FF978EDB-5F52-504E-97C6-A58E6BA224E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3" creationId="{A316248E-A6CB-A0B5-2F06-CFE70D7386C9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876749716" sldId="2147483651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2" creationId="{A5E9D775-F6CC-373E-59E9-733A894CE0D5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3" creationId="{8A1B44E5-651F-69E9-3CE4-1436A256826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3159592507" sldId="2147483652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3" creationId="{C685A6F0-46BA-1392-9D3A-EEB8258B868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4" creationId="{CA89A05A-1D67-3E58-E8B7-E83A7645007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737182433" sldId="2147483653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2" creationId="{8708E09E-9365-5B5A-BAEC-D42176719BAF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3" creationId="{C23564CF-5010-8670-804F-CD9855723DA7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4" creationId="{65ACD0DF-19A1-CB89-074E-65A71F129AA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5" creationId="{C8948A43-BF6C-1500-41C6-8F4C085BBB3B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6" creationId="{1B323149-969B-9BD6-94FF-9C390A1E0D6C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549421126" sldId="2147483656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2" creationId="{58B65CA6-DEDC-D345-87C6-2B647EF6167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3" creationId="{A234FB66-34CB-D54F-901B-463F41987112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4" creationId="{81214F8F-DC2A-0D68-95CD-23642BBBD801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803478031" sldId="2147483657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2" creationId="{F526A7AE-AB11-C684-A9BF-54A664F013F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3" creationId="{C18C5981-53C6-3AAA-2484-E58FBD5E9BA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4" creationId="{E2BFB993-6317-0FF6-AA42-9CEA85DBB75F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486859533" sldId="214748365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2" creationId="{827685F6-C049-9913-DC0B-3B932D24BC30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3" creationId="{EEEB0B2C-459A-7758-7E8B-60724828F43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3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5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120818" y="469967"/>
            <a:ext cx="5195461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Histopathological findings in muscle biopsy from the patient e. Light microscopy analysis demonstrated: (A) low fiber size variability, numerous fibers containing multiple cytoplasmic vacuoles, internalized nuclei, some fiber splitting, and low increased endomysial connective tissue; (B) no granular or dotted aspect of the muscle cell membrane but red labeling of cytoplasmic vacuoles; (C) absence of myofibrillar disorganization and no accumulation of mitochondria in the periphery of the fibers; (D, E) ) no predominance of fiber type but selective atrophy of type I fibers; (F) dystrophin labeling on vacuoles and muscle fiber membranes; (G) deposition of complement C5b-9 within vacuoles and along muscle fiber membranes; (H–J) positive labeling of p62, LC3, and LAMP-2 (red) on autophagic vacuoles and membranes of abnormal fibers (nuclei counterstained in blue); (K) weak acid phosphatase activity within vacuoles. Abbreviations: C5b-9, complement membrane attack complex; DYS, dystrophin; GT, Gömöri trichrome; H&amp;E, hematoxylin and eosin; LAMP-2, lysosome-associated membrane protein 2; LC3, autophagy marker light chain 3; NADH-TR, reduced nicotinamide adenine dinucleotide dehydrogenase-tetrazolium reductase. Scale bar = 100 µm for all panels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AF45F89-BEF0-826D-4DC4-1CCB0C8901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4500" y="131309"/>
            <a:ext cx="6546682" cy="6595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3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05:20Z</dcterms:modified>
</cp:coreProperties>
</file>